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F13791-BA37-4580-8DD0-ABC58A436AD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9C4EC7-6171-4EC7-A5B4-1C8280AC02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E4B1E1-AC49-44BB-9CEE-1125F23A5F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ED5E96-3922-4FEE-BE32-35EC35BC988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6F1D7EB-BD90-4AF4-AA2B-84EB27CCE84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0DEB21E-0773-4669-8DA5-9363A7BE3E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25B5302-D874-4004-B076-AEC33D570C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5406706-3B4C-4B10-8A66-6A31DE85DC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9157D96-84E1-4928-976F-DC206E0220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29C8FE3-F0D8-4913-BDCA-060C2E7A26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83F8E32-6CE3-4BCD-8AB2-E3B0BF9E25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598EE5-0354-49B8-8E64-089CCA7402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D3860EB-9C0E-4A0B-B096-7DDA8D7AC5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4ABC34C-6C12-4B49-8464-C3CB30A443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9ECDE15-CD24-444A-BF0D-A33EA22791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03B3175-8BAF-44AD-B2F2-B13642B6CAB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C68769A-2615-45DE-966F-FFA29811FE2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6AF42A-7AD2-4033-A08C-1B4B8580B5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EFF0E0-E156-43F2-A45A-2E92884DF4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E87710-33C9-43F9-A8CB-88852D9DEF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F72933-BAB9-4DA8-A269-A83E74F476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7CDB47-AE8A-44BC-A7BA-6FD86F5F89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CA1AF4-AE86-44B1-8891-50540672DD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5AA58F-1BF3-489A-A066-35D54A6A36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D91987-783F-4849-89BD-0A7556CDD063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BEB9F0-3E41-4579-A97E-4EB08085389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2" name=""/>
          <p:cNvGraphicFramePr/>
          <p:nvPr/>
        </p:nvGraphicFramePr>
        <p:xfrm>
          <a:off x="765000" y="690480"/>
          <a:ext cx="5400720" cy="8120160"/>
        </p:xfrm>
        <a:graphic>
          <a:graphicData uri="http://schemas.openxmlformats.org/drawingml/2006/table">
            <a:tbl>
              <a:tblPr/>
              <a:tblGrid>
                <a:gridCol w="2087640"/>
                <a:gridCol w="3313080"/>
              </a:tblGrid>
              <a:tr h="262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be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quence (5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´-3´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395a/b/d/e/f/g/h/i/j/n/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GTTCCCCCAAACACTTCA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528a/b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CCTCTGCATGCCCCTTCC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82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TTTGCTGATGGTCATCTA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C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CACCGCGCAGCACCCATCC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C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CTGCATGCCCCTTCCACCGC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C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CCACTGACGATAGCATGAA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C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CTCCTCTAACCTCCTCCGG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C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TAGCCCCTCCAATCCCCTC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171p/q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GAGATATTGACGCGGCTCA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C1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AGCCCCTCCAATTCCCTCC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C1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TGACCAAGTCAATGCACCA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C1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CCGTAGTCCCCGAGCCTA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169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GGGCAAATCATGCTTGGC 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C1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CCCCCTCAATCCACTCCA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C1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CTCTCGAGAGCCTCTCCGCA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C2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GCGACTCCGCTGGGGAT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C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CATATTTTCGACGAACTTA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C3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CCCCTCCAATCCCCTCCG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169w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GGCAGCTCATCCTTGGCT 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C5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AGCATCTT CATCACAGC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169C Real F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TTGCCATGTGCTATGAGGTA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169C Real 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GCCATACACGAGAGGAAGAG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169R Real F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GTGGGATGCAGCCAAGGA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R169R Real 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AACAAGATGTAGCCAAGGA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PC2 F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ATGGCAAGCTCACTGG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PC2 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TGTCACCGGTGAAGTC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RMZM2G006593 oute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TCGTTTTGTAGAAGGGCAAACC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RMZM2G006593 inne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GGCAAACCAGATATCTGCCAC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RMZM2G053779 oute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ATAGAATACTGGAGAATGAAG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RMZM2G053779 inne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ATGAAGCAGTTTTATTGAGG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83" name="矩形 2"/>
          <p:cNvSpPr/>
          <p:nvPr/>
        </p:nvSpPr>
        <p:spPr>
          <a:xfrm>
            <a:off x="4491000" y="108000"/>
            <a:ext cx="2239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table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22T01:51:10Z</dcterms:created>
  <dc:creator>MC SYSTEM</dc:creator>
  <dc:description/>
  <dc:language>en-US</dc:language>
  <cp:lastModifiedBy>MC SYSTEM</cp:lastModifiedBy>
  <dcterms:modified xsi:type="dcterms:W3CDTF">2011-10-25T05:26:53Z</dcterms:modified>
  <cp:revision>18</cp:revision>
  <dc:subject/>
  <dc:title>幻灯片 1</dc:title>
</cp:coreProperties>
</file>